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8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216"/>
      </p:cViewPr>
      <p:guideLst>
        <p:guide orient="horz" pos="31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794617727248318"/>
          <c:y val="5.1400554097404488E-2"/>
          <c:w val="0.71362607249784804"/>
          <c:h val="0.830867964421113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</c:spPr>
          <c:invertIfNegative val="0"/>
          <c:cat>
            <c:strRef>
              <c:f>Sheet1!$F$17:$I$17</c:f>
              <c:strCache>
                <c:ptCount val="4"/>
                <c:pt idx="0">
                  <c:v>Mock</c:v>
                </c:pt>
                <c:pt idx="1">
                  <c:v>RDV</c:v>
                </c:pt>
                <c:pt idx="2">
                  <c:v>Mock</c:v>
                </c:pt>
                <c:pt idx="3">
                  <c:v>RSV</c:v>
                </c:pt>
              </c:strCache>
            </c:strRef>
          </c:cat>
          <c:val>
            <c:numRef>
              <c:f>Sheet1!$F$18:$I$18</c:f>
              <c:numCache>
                <c:formatCode>General</c:formatCode>
                <c:ptCount val="4"/>
                <c:pt idx="0">
                  <c:v>30643.333333333332</c:v>
                </c:pt>
                <c:pt idx="1">
                  <c:v>38322.666666666701</c:v>
                </c:pt>
                <c:pt idx="2">
                  <c:v>34504.666666666664</c:v>
                </c:pt>
                <c:pt idx="3">
                  <c:v>50927.6666666667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801344"/>
        <c:axId val="75802880"/>
      </c:barChart>
      <c:catAx>
        <c:axId val="758013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5802880"/>
        <c:crosses val="autoZero"/>
        <c:auto val="1"/>
        <c:lblAlgn val="ctr"/>
        <c:lblOffset val="100"/>
        <c:noMultiLvlLbl val="0"/>
      </c:catAx>
      <c:valAx>
        <c:axId val="7580288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758013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7965BD-FD03-4C8F-A197-EC50D7697508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BED53-BBA4-43C4-9D66-9DCD9637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7183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61343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1" y="39673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3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1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1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25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25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94" y="2217387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94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25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12" y="39443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25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9587173"/>
              </p:ext>
            </p:extLst>
          </p:nvPr>
        </p:nvGraphicFramePr>
        <p:xfrm>
          <a:off x="1447809" y="1447800"/>
          <a:ext cx="310991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 rot="16200000">
            <a:off x="641868" y="2536195"/>
            <a:ext cx="13715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ads per mill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90600" y="990600"/>
            <a:ext cx="48460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iR168 accumulation in mock and virus infected rice plant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590800" y="304800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7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609600" y="4191000"/>
            <a:ext cx="5715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Figure S7.</a:t>
            </a:r>
            <a:r>
              <a:rPr lang="en-US" sz="1200" dirty="0" smtClean="0"/>
              <a:t>  </a:t>
            </a:r>
            <a:r>
              <a:rPr lang="en-US" sz="1200" dirty="0"/>
              <a:t>miR168 is not significantly induced in rice upon infection with viruses.  Small RNAs derived from </a:t>
            </a:r>
            <a:r>
              <a:rPr lang="en-US" sz="1200" i="1" dirty="0"/>
              <a:t>Rice stripe virus</a:t>
            </a:r>
            <a:r>
              <a:rPr lang="en-US" sz="1200" dirty="0"/>
              <a:t> (RSV) and </a:t>
            </a:r>
            <a:r>
              <a:rPr lang="en-US" sz="1200" i="1" dirty="0"/>
              <a:t>Rice dwarf virus</a:t>
            </a:r>
            <a:r>
              <a:rPr lang="en-US" sz="1200" dirty="0"/>
              <a:t> (RDV)-infected rice plants were used for analysis.  Mock represented uninfected control plant.  </a:t>
            </a:r>
          </a:p>
        </p:txBody>
      </p:sp>
    </p:spTree>
    <p:extLst>
      <p:ext uri="{BB962C8B-B14F-4D97-AF65-F5344CB8AC3E}">
        <p14:creationId xmlns:p14="http://schemas.microsoft.com/office/powerpoint/2010/main" val="1606536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8</TotalTime>
  <Words>60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128</cp:revision>
  <dcterms:created xsi:type="dcterms:W3CDTF">2006-08-16T00:00:00Z</dcterms:created>
  <dcterms:modified xsi:type="dcterms:W3CDTF">2014-08-25T07:06:56Z</dcterms:modified>
</cp:coreProperties>
</file>